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7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373" autoAdjust="0"/>
    <p:restoredTop sz="81769" autoAdjust="0"/>
  </p:normalViewPr>
  <p:slideViewPr>
    <p:cSldViewPr snapToGrid="0">
      <p:cViewPr varScale="1">
        <p:scale>
          <a:sx n="103" d="100"/>
          <a:sy n="103" d="100"/>
        </p:scale>
        <p:origin x="12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9924B4-3829-4100-A561-EC32376D00F2}" type="datetimeFigureOut">
              <a:rPr lang="en-US" smtClean="0"/>
              <a:t>2/10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133745-15A9-490B-9F8C-F25713016D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6882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C5C92CA-2F5E-0D8B-3919-89ECE32F5C2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DD611940-1AA7-2517-05B5-9CE87119EC9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797A0271-BF49-F1F1-0F32-9EB42EEE7857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A1AA931-CD45-FAAE-D2DE-189D126A0DD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17D8E3-4DED-884B-B60B-A5855D3C818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6824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A850E5-6442-42F2-D226-F5AD1FA33A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5331EFF-DBA4-D067-D1E1-AEE7AAA89F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7FA36A-4360-FFBD-40A0-7DF5FB0F29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45E06-5C83-458A-9DF7-48767866B4E2}" type="datetimeFigureOut">
              <a:rPr lang="en-US" smtClean="0"/>
              <a:t>2/10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C2276D-E1B1-12C5-F6AC-875D9BEA64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72C58F-C3F3-3B8F-D26E-495B1B036F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EFAD-EBE3-40B3-B099-1C4C1E2C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5496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ADAB3A-8CDC-B0FE-ADCA-7ABC9CDF1D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A36B639-8B28-52A1-E626-0E9741ED3C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9ABC69-742B-5C21-8DF7-5AC81FEDC9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45E06-5C83-458A-9DF7-48767866B4E2}" type="datetimeFigureOut">
              <a:rPr lang="en-US" smtClean="0"/>
              <a:t>2/10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5E5BD6-87A7-8B2D-BACB-4C9C930956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25BAA5-C323-D167-D5C6-C0D8C884A8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EFAD-EBE3-40B3-B099-1C4C1E2C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126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DD5CB0A-730D-3159-5DCA-6018A81B77F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6634F9-01F1-3E76-F3DB-47321F9065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66B26C-6235-6365-C643-93AC1B327C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45E06-5C83-458A-9DF7-48767866B4E2}" type="datetimeFigureOut">
              <a:rPr lang="en-US" smtClean="0"/>
              <a:t>2/10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42738E-E7F0-B07D-F280-A759455AE1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210627-F80A-44A9-5ED4-014DF44D8F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EFAD-EBE3-40B3-B099-1C4C1E2C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4845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5CB562-2805-E552-ECFD-F4D1ED8AED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0979EB-6B3C-620E-89CB-2EF72A622D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38EC9D-BD81-A064-9CF5-7744229784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45E06-5C83-458A-9DF7-48767866B4E2}" type="datetimeFigureOut">
              <a:rPr lang="en-US" smtClean="0"/>
              <a:t>2/10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FBB220-3E12-466E-34DD-8BEC86BAA1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43F6A2-09F0-A519-01B3-ABDC8123D2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EFAD-EBE3-40B3-B099-1C4C1E2C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0651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E407C6-30E0-FD6D-AE3B-651C415478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80A9F7-0D11-AAA9-089D-BBFD629CD3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EC7623-9AA7-4D26-2BD5-78E9239638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45E06-5C83-458A-9DF7-48767866B4E2}" type="datetimeFigureOut">
              <a:rPr lang="en-US" smtClean="0"/>
              <a:t>2/10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0CD998-A62B-3EAB-AD43-2262B3BD81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48134D-CDA1-F8AD-257A-9D49EA8C4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EFAD-EBE3-40B3-B099-1C4C1E2C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4933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423EE7-7198-B6D4-EAD6-896A4BAFC3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45FFFD-9D01-FF65-CA26-882287B58D9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4362B8-1701-2C6E-3155-A28C18854A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31708C-857C-81FE-52EA-33D3E95721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45E06-5C83-458A-9DF7-48767866B4E2}" type="datetimeFigureOut">
              <a:rPr lang="en-US" smtClean="0"/>
              <a:t>2/10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2792BD-2184-966A-D51E-5207397B85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1364F2-BF3A-37F6-9F6E-C3BA854BFE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EFAD-EBE3-40B3-B099-1C4C1E2C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439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32038B-6B9C-FD7D-4F58-DC8BF74A97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FC7DF5-E5D3-760B-10A4-7821F4E568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B8EB00-A3E8-5604-F0FA-CDB414C9B3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4F7319B-1B91-4EEA-1993-52500F9463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FB94767-A38C-D15E-5AF5-55C1517C96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38ECBF4-B8BA-9662-716F-C611AA93F7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45E06-5C83-458A-9DF7-48767866B4E2}" type="datetimeFigureOut">
              <a:rPr lang="en-US" smtClean="0"/>
              <a:t>2/10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4F97013-18FD-9487-03AB-13DC4453A6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503A00B-C107-1CC4-29CB-F5C1066A7C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EFAD-EBE3-40B3-B099-1C4C1E2C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092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63FB76-52E4-FE0C-CF92-C25B69E968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386EAFC-0A65-AC19-7CFB-50CCFDC17B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45E06-5C83-458A-9DF7-48767866B4E2}" type="datetimeFigureOut">
              <a:rPr lang="en-US" smtClean="0"/>
              <a:t>2/10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10425B9-3F71-6F93-9DDC-8704B71FC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868DC42-995F-F7F6-5585-D5A1F31D19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EFAD-EBE3-40B3-B099-1C4C1E2C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7943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87E9746-4D90-8DDD-4120-73421E9533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45E06-5C83-458A-9DF7-48767866B4E2}" type="datetimeFigureOut">
              <a:rPr lang="en-US" smtClean="0"/>
              <a:t>2/10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E08DD51-DA8C-D133-FD26-04DAD7531F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2AFD894-77B3-7414-80EF-ADFAE7B5C3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EFAD-EBE3-40B3-B099-1C4C1E2C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459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207368-53DD-DFF2-158A-D8D0247459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A0A3FC-E8B4-BA75-9E01-309F3DD11B9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71738A-81F3-961D-9DCE-637B7E5562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BBB415-9357-E401-97B4-8A876CA0BF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45E06-5C83-458A-9DF7-48767866B4E2}" type="datetimeFigureOut">
              <a:rPr lang="en-US" smtClean="0"/>
              <a:t>2/10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A82DF3-AEBE-8009-6EEB-1B2951E0A9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D263DF-C48B-F064-2C6B-84E17588E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EFAD-EBE3-40B3-B099-1C4C1E2C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767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2346BC-66AA-9C95-7B15-3C34DCAC76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37AFF1F-C8AC-5126-B452-9E8D59866C8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379C5A-85DF-655B-FC0D-5CF872CA46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0BF7FC-9842-3974-245D-D99DF008E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45E06-5C83-458A-9DF7-48767866B4E2}" type="datetimeFigureOut">
              <a:rPr lang="en-US" smtClean="0"/>
              <a:t>2/10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99162E-5408-EB16-E757-4AC2AFCAB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890436-432F-23DD-EE4D-01CDFB1886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5EFAD-EBE3-40B3-B099-1C4C1E2C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175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B930472-8C15-48B4-4032-FC59EC52DC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36BA98-D1B3-00E3-65EE-B82E829822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366909-E4B1-79BA-BF3E-B728129C85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B45E06-5C83-458A-9DF7-48767866B4E2}" type="datetimeFigureOut">
              <a:rPr lang="en-US" smtClean="0"/>
              <a:t>2/10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CC49ED-E1FD-D801-D21E-A69F1F6D34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38E8CD-CB8D-77EF-57B6-A9B69E52F9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05EFAD-EBE3-40B3-B099-1C4C1E2CDC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4118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81FE8C8-4BF8-31F9-E108-8E4969A139B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86AEBA75-2A39-B78F-BB7A-0841EC22FCCB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221254" y="25720"/>
            <a:ext cx="11629963" cy="235597"/>
          </a:xfrm>
        </p:spPr>
        <p:txBody>
          <a:bodyPr>
            <a:noAutofit/>
          </a:bodyPr>
          <a:lstStyle/>
          <a:p>
            <a:pPr algn="ctr"/>
            <a:r>
              <a:rPr lang="en-US" sz="1600" b="1" dirty="0">
                <a:latin typeface="Calibri" panose="020F0502020204030204" pitchFamily="34" charset="0"/>
                <a:cs typeface="Calibri" panose="020F0502020204030204" pitchFamily="34" charset="0"/>
              </a:rPr>
              <a:t>TOWARDS AN IMMUNOLOGICAL DIAGNOSTIC FRAMEWORK EOE AND ITS SUBTYPES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FB71F818-EF58-17BB-8755-A55A7972E07F}"/>
              </a:ext>
            </a:extLst>
          </p:cNvPr>
          <p:cNvGrpSpPr/>
          <p:nvPr/>
        </p:nvGrpSpPr>
        <p:grpSpPr>
          <a:xfrm>
            <a:off x="1196924" y="402114"/>
            <a:ext cx="10773822" cy="6031921"/>
            <a:chOff x="134461" y="354365"/>
            <a:chExt cx="11820998" cy="6433041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004986D-472A-B845-B5C5-5BF2D075B5A5}"/>
                </a:ext>
              </a:extLst>
            </p:cNvPr>
            <p:cNvSpPr txBox="1"/>
            <p:nvPr/>
          </p:nvSpPr>
          <p:spPr>
            <a:xfrm>
              <a:off x="134461" y="486361"/>
              <a:ext cx="3269141" cy="35951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i="1" dirty="0"/>
                <a:t>Tier 1: Histology and Classic Markers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2168ED6-68EC-1054-8A6E-780A1B9F3878}"/>
                </a:ext>
              </a:extLst>
            </p:cNvPr>
            <p:cNvSpPr txBox="1"/>
            <p:nvPr/>
          </p:nvSpPr>
          <p:spPr>
            <a:xfrm>
              <a:off x="3564592" y="389122"/>
              <a:ext cx="260574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i="1" dirty="0"/>
                <a:t>Tier 2: Immune Axis Profiling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F966E39-7E75-A8AF-7006-48952C8BC866}"/>
                </a:ext>
              </a:extLst>
            </p:cNvPr>
            <p:cNvSpPr txBox="1"/>
            <p:nvPr/>
          </p:nvSpPr>
          <p:spPr>
            <a:xfrm>
              <a:off x="6758866" y="354365"/>
              <a:ext cx="3076530" cy="35951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i="1" dirty="0"/>
                <a:t>Tier 3: Subtype Stratification</a:t>
              </a:r>
            </a:p>
          </p:txBody>
        </p: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9F39F5B2-1EB8-89A3-72B1-392819EE7179}"/>
                </a:ext>
              </a:extLst>
            </p:cNvPr>
            <p:cNvGrpSpPr/>
            <p:nvPr/>
          </p:nvGrpSpPr>
          <p:grpSpPr>
            <a:xfrm>
              <a:off x="5629510" y="906246"/>
              <a:ext cx="6325949" cy="5881160"/>
              <a:chOff x="5629510" y="906246"/>
              <a:chExt cx="6325949" cy="5881160"/>
            </a:xfrm>
          </p:grpSpPr>
          <p:cxnSp>
            <p:nvCxnSpPr>
              <p:cNvPr id="17" name="Straight Arrow Connector 16">
                <a:extLst>
                  <a:ext uri="{FF2B5EF4-FFF2-40B4-BE49-F238E27FC236}">
                    <a16:creationId xmlns:a16="http://schemas.microsoft.com/office/drawing/2014/main" id="{C8153589-8B41-9961-6927-4BA595323F3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29510" y="1840277"/>
                <a:ext cx="1063812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accent6"/>
              </a:lnRef>
              <a:fillRef idx="0">
                <a:schemeClr val="accent6"/>
              </a:fillRef>
              <a:effectRef idx="2">
                <a:schemeClr val="accent6"/>
              </a:effectRef>
              <a:fontRef idx="minor">
                <a:schemeClr val="tx1"/>
              </a:fontRef>
            </p:style>
          </p:cxn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41C27E26-1766-9306-25AB-98B831B8C420}"/>
                  </a:ext>
                </a:extLst>
              </p:cNvPr>
              <p:cNvSpPr txBox="1"/>
              <p:nvPr/>
            </p:nvSpPr>
            <p:spPr>
              <a:xfrm>
                <a:off x="5900905" y="1469936"/>
                <a:ext cx="553571" cy="3395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No</a:t>
                </a:r>
              </a:p>
            </p:txBody>
          </p:sp>
          <p:sp>
            <p:nvSpPr>
              <p:cNvPr id="29" name="Diamond 28">
                <a:extLst>
                  <a:ext uri="{FF2B5EF4-FFF2-40B4-BE49-F238E27FC236}">
                    <a16:creationId xmlns:a16="http://schemas.microsoft.com/office/drawing/2014/main" id="{1D13A1B2-48D9-C10B-BFA6-D1F7EBC43FCA}"/>
                  </a:ext>
                </a:extLst>
              </p:cNvPr>
              <p:cNvSpPr/>
              <p:nvPr/>
            </p:nvSpPr>
            <p:spPr>
              <a:xfrm>
                <a:off x="6641138" y="906246"/>
                <a:ext cx="2095492" cy="1843049"/>
              </a:xfrm>
              <a:prstGeom prst="diamond">
                <a:avLst/>
              </a:prstGeom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/>
                  <a:t>Th1 signature? (STAT1, IRF1, CXCL10)</a:t>
                </a:r>
              </a:p>
            </p:txBody>
          </p:sp>
          <p:sp>
            <p:nvSpPr>
              <p:cNvPr id="30" name="Diamond 29">
                <a:extLst>
                  <a:ext uri="{FF2B5EF4-FFF2-40B4-BE49-F238E27FC236}">
                    <a16:creationId xmlns:a16="http://schemas.microsoft.com/office/drawing/2014/main" id="{6B746E87-432A-0093-929C-38F6C07B2809}"/>
                  </a:ext>
                </a:extLst>
              </p:cNvPr>
              <p:cNvSpPr/>
              <p:nvPr/>
            </p:nvSpPr>
            <p:spPr>
              <a:xfrm>
                <a:off x="6635593" y="2962782"/>
                <a:ext cx="2095492" cy="1801138"/>
              </a:xfrm>
              <a:prstGeom prst="diamond">
                <a:avLst/>
              </a:prstGeom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/>
                  <a:t>Mixed signature? (↑ </a:t>
                </a:r>
                <a:r>
                  <a:rPr lang="en-US" sz="1200" b="1" dirty="0"/>
                  <a:t>CXCR3</a:t>
                </a:r>
                <a:r>
                  <a:rPr lang="en-US" sz="1200" dirty="0"/>
                  <a:t> ligands + mild </a:t>
                </a:r>
                <a:r>
                  <a:rPr lang="en-US" sz="1200" b="1" dirty="0"/>
                  <a:t>Ig</a:t>
                </a:r>
                <a:r>
                  <a:rPr lang="en-US" sz="1200" dirty="0"/>
                  <a:t>)</a:t>
                </a:r>
              </a:p>
            </p:txBody>
          </p:sp>
          <p:cxnSp>
            <p:nvCxnSpPr>
              <p:cNvPr id="32" name="Straight Arrow Connector 31">
                <a:extLst>
                  <a:ext uri="{FF2B5EF4-FFF2-40B4-BE49-F238E27FC236}">
                    <a16:creationId xmlns:a16="http://schemas.microsoft.com/office/drawing/2014/main" id="{74652C33-2637-E8E5-48B3-1ECF88BFD7E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669616" y="1852447"/>
                <a:ext cx="1132545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accent6"/>
              </a:lnRef>
              <a:fillRef idx="0">
                <a:schemeClr val="accent6"/>
              </a:fillRef>
              <a:effectRef idx="2">
                <a:schemeClr val="accent6"/>
              </a:effectRef>
              <a:fontRef idx="minor">
                <a:schemeClr val="tx1"/>
              </a:fontRef>
            </p:style>
          </p:cxnSp>
          <p:sp>
            <p:nvSpPr>
              <p:cNvPr id="34" name="Diamond 33">
                <a:extLst>
                  <a:ext uri="{FF2B5EF4-FFF2-40B4-BE49-F238E27FC236}">
                    <a16:creationId xmlns:a16="http://schemas.microsoft.com/office/drawing/2014/main" id="{0C4A0269-E675-54A6-B39B-D2FB45DAAA8A}"/>
                  </a:ext>
                </a:extLst>
              </p:cNvPr>
              <p:cNvSpPr/>
              <p:nvPr/>
            </p:nvSpPr>
            <p:spPr>
              <a:xfrm>
                <a:off x="6531312" y="4986268"/>
                <a:ext cx="2290099" cy="1801138"/>
              </a:xfrm>
              <a:prstGeom prst="diamond">
                <a:avLst/>
              </a:prstGeom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/>
                  <a:t>Humoral activation only? (↑ </a:t>
                </a:r>
                <a:r>
                  <a:rPr lang="en-US" sz="1100" b="1" dirty="0"/>
                  <a:t>IGHV/IGKV </a:t>
                </a:r>
                <a:r>
                  <a:rPr lang="en-US" sz="1100" dirty="0"/>
                  <a:t>without chemokines)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0BB90DCE-9B35-A300-1488-4C2549957EF8}"/>
                  </a:ext>
                </a:extLst>
              </p:cNvPr>
              <p:cNvSpPr txBox="1"/>
              <p:nvPr/>
            </p:nvSpPr>
            <p:spPr>
              <a:xfrm>
                <a:off x="7759697" y="2676994"/>
                <a:ext cx="506230" cy="3395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No</a:t>
                </a:r>
              </a:p>
            </p:txBody>
          </p:sp>
          <p:cxnSp>
            <p:nvCxnSpPr>
              <p:cNvPr id="39" name="Straight Arrow Connector 38">
                <a:extLst>
                  <a:ext uri="{FF2B5EF4-FFF2-40B4-BE49-F238E27FC236}">
                    <a16:creationId xmlns:a16="http://schemas.microsoft.com/office/drawing/2014/main" id="{1D62F2C4-C72B-7D84-63B2-5F750BD2E730}"/>
                  </a:ext>
                </a:extLst>
              </p:cNvPr>
              <p:cNvCxnSpPr>
                <a:cxnSpLocks/>
                <a:stCxn id="29" idx="2"/>
              </p:cNvCxnSpPr>
              <p:nvPr/>
            </p:nvCxnSpPr>
            <p:spPr>
              <a:xfrm flipH="1">
                <a:off x="7686112" y="2749295"/>
                <a:ext cx="2772" cy="232193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accent6"/>
              </a:lnRef>
              <a:fillRef idx="0">
                <a:schemeClr val="accent6"/>
              </a:fillRef>
              <a:effectRef idx="2">
                <a:schemeClr val="accent6"/>
              </a:effectRef>
              <a:fontRef idx="minor">
                <a:schemeClr val="tx1"/>
              </a:fontRef>
            </p:style>
          </p:cxn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9736E66F-424E-FF53-1D73-311C0A6F2CE7}"/>
                  </a:ext>
                </a:extLst>
              </p:cNvPr>
              <p:cNvSpPr txBox="1"/>
              <p:nvPr/>
            </p:nvSpPr>
            <p:spPr>
              <a:xfrm>
                <a:off x="8994589" y="1530115"/>
                <a:ext cx="577576" cy="3395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Yes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5A462ADB-380F-9FDF-8C1C-A30D8330795E}"/>
                  </a:ext>
                </a:extLst>
              </p:cNvPr>
              <p:cNvSpPr txBox="1"/>
              <p:nvPr/>
            </p:nvSpPr>
            <p:spPr>
              <a:xfrm>
                <a:off x="8934064" y="3558265"/>
                <a:ext cx="577576" cy="3395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Yes</a:t>
                </a:r>
              </a:p>
            </p:txBody>
          </p:sp>
          <p:cxnSp>
            <p:nvCxnSpPr>
              <p:cNvPr id="44" name="Straight Arrow Connector 43">
                <a:extLst>
                  <a:ext uri="{FF2B5EF4-FFF2-40B4-BE49-F238E27FC236}">
                    <a16:creationId xmlns:a16="http://schemas.microsoft.com/office/drawing/2014/main" id="{DB1FB721-2250-5EAE-7C0D-F8802DA2124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652056" y="3886209"/>
                <a:ext cx="1167662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accent6"/>
              </a:lnRef>
              <a:fillRef idx="0">
                <a:schemeClr val="accent6"/>
              </a:fillRef>
              <a:effectRef idx="2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48" name="Straight Arrow Connector 47">
                <a:extLst>
                  <a:ext uri="{FF2B5EF4-FFF2-40B4-BE49-F238E27FC236}">
                    <a16:creationId xmlns:a16="http://schemas.microsoft.com/office/drawing/2014/main" id="{94B2AA3E-A7F4-882B-2742-D94F87565BE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667734" y="5925733"/>
                <a:ext cx="1167662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accent6"/>
              </a:lnRef>
              <a:fillRef idx="0">
                <a:schemeClr val="accent6"/>
              </a:fillRef>
              <a:effectRef idx="2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51" name="Straight Arrow Connector 50">
                <a:extLst>
                  <a:ext uri="{FF2B5EF4-FFF2-40B4-BE49-F238E27FC236}">
                    <a16:creationId xmlns:a16="http://schemas.microsoft.com/office/drawing/2014/main" id="{896FC5B3-15B5-C90C-F506-19852284D94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86111" y="4728663"/>
                <a:ext cx="0" cy="273643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accent6"/>
              </a:lnRef>
              <a:fillRef idx="0">
                <a:schemeClr val="accent6"/>
              </a:fillRef>
              <a:effectRef idx="2">
                <a:schemeClr val="accent6"/>
              </a:effectRef>
              <a:fontRef idx="minor">
                <a:schemeClr val="tx1"/>
              </a:fontRef>
            </p:style>
          </p:cxnSp>
          <p:sp>
            <p:nvSpPr>
              <p:cNvPr id="56" name="Rectangle: Diagonal Corners Rounded 55">
                <a:extLst>
                  <a:ext uri="{FF2B5EF4-FFF2-40B4-BE49-F238E27FC236}">
                    <a16:creationId xmlns:a16="http://schemas.microsoft.com/office/drawing/2014/main" id="{6942D508-DC16-9AE9-5924-33753E314572}"/>
                  </a:ext>
                </a:extLst>
              </p:cNvPr>
              <p:cNvSpPr/>
              <p:nvPr/>
            </p:nvSpPr>
            <p:spPr>
              <a:xfrm>
                <a:off x="9794257" y="3520882"/>
                <a:ext cx="2024309" cy="654825"/>
              </a:xfrm>
              <a:prstGeom prst="round2DiagRect">
                <a:avLst>
                  <a:gd name="adj1" fmla="val 16667"/>
                  <a:gd name="adj2" fmla="val 0"/>
                </a:avLst>
              </a:prstGeom>
              <a:solidFill>
                <a:schemeClr val="accent5"/>
              </a:solidFill>
              <a:ln>
                <a:solidFill>
                  <a:schemeClr val="accent5"/>
                </a:solidFill>
              </a:ln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/>
              </a:p>
              <a:p>
                <a:pPr algn="ctr"/>
                <a:r>
                  <a:rPr lang="en-US" sz="1400" dirty="0"/>
                  <a:t>EoE-like Esophagitis</a:t>
                </a:r>
              </a:p>
              <a:p>
                <a:pPr algn="ctr"/>
                <a:endParaRPr lang="en-US" dirty="0"/>
              </a:p>
            </p:txBody>
          </p:sp>
          <p:sp>
            <p:nvSpPr>
              <p:cNvPr id="57" name="Rectangle: Diagonal Corners Rounded 56">
                <a:extLst>
                  <a:ext uri="{FF2B5EF4-FFF2-40B4-BE49-F238E27FC236}">
                    <a16:creationId xmlns:a16="http://schemas.microsoft.com/office/drawing/2014/main" id="{955863AE-85E6-0C3A-78F4-514FC27872F7}"/>
                  </a:ext>
                </a:extLst>
              </p:cNvPr>
              <p:cNvSpPr/>
              <p:nvPr/>
            </p:nvSpPr>
            <p:spPr>
              <a:xfrm>
                <a:off x="9802161" y="5524035"/>
                <a:ext cx="2153298" cy="684681"/>
              </a:xfrm>
              <a:prstGeom prst="round2DiagRect">
                <a:avLst>
                  <a:gd name="adj1" fmla="val 16667"/>
                  <a:gd name="adj2" fmla="val 0"/>
                </a:avLst>
              </a:prstGeom>
              <a:solidFill>
                <a:srgbClr val="92D050"/>
              </a:solidFill>
              <a:ln>
                <a:solidFill>
                  <a:srgbClr val="92D050"/>
                </a:solidFill>
              </a:ln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  <a:p>
                <a:pPr algn="ctr"/>
                <a:r>
                  <a:rPr lang="en-US" sz="1400" dirty="0"/>
                  <a:t>Nonspecific Esophagitis</a:t>
                </a:r>
              </a:p>
              <a:p>
                <a:pPr algn="ctr"/>
                <a:endParaRPr lang="en-US" dirty="0"/>
              </a:p>
            </p:txBody>
          </p:sp>
          <p:sp>
            <p:nvSpPr>
              <p:cNvPr id="59" name="Rectangle: Diagonal Corners Rounded 58">
                <a:extLst>
                  <a:ext uri="{FF2B5EF4-FFF2-40B4-BE49-F238E27FC236}">
                    <a16:creationId xmlns:a16="http://schemas.microsoft.com/office/drawing/2014/main" id="{C175058A-9693-2A36-EB66-F67DFC80FF0F}"/>
                  </a:ext>
                </a:extLst>
              </p:cNvPr>
              <p:cNvSpPr/>
              <p:nvPr/>
            </p:nvSpPr>
            <p:spPr>
              <a:xfrm>
                <a:off x="9794256" y="1530115"/>
                <a:ext cx="1906874" cy="657699"/>
              </a:xfrm>
              <a:prstGeom prst="round2DiagRect">
                <a:avLst/>
              </a:prstGeom>
              <a:solidFill>
                <a:srgbClr val="FFC000"/>
              </a:solidFill>
              <a:ln>
                <a:solidFill>
                  <a:srgbClr val="FFC000"/>
                </a:solidFill>
              </a:ln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  <a:p>
                <a:pPr algn="ctr"/>
                <a:r>
                  <a:rPr lang="en-US" sz="1400" dirty="0"/>
                  <a:t>Lymphocytic Esophagitis</a:t>
                </a:r>
              </a:p>
              <a:p>
                <a:pPr algn="ctr"/>
                <a:endParaRPr lang="en-US" dirty="0"/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CB6A2CD6-E57D-4D2D-208C-E64C6D7CDFF7}"/>
                  </a:ext>
                </a:extLst>
              </p:cNvPr>
              <p:cNvSpPr txBox="1"/>
              <p:nvPr/>
            </p:nvSpPr>
            <p:spPr>
              <a:xfrm>
                <a:off x="8994589" y="5526831"/>
                <a:ext cx="517050" cy="3395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Yes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153A5FB3-8B05-C3DE-261B-48893D3CDD0C}"/>
                  </a:ext>
                </a:extLst>
              </p:cNvPr>
              <p:cNvSpPr txBox="1"/>
              <p:nvPr/>
            </p:nvSpPr>
            <p:spPr>
              <a:xfrm>
                <a:off x="7746626" y="4716723"/>
                <a:ext cx="506227" cy="3395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No</a:t>
                </a:r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4FB588AF-9F10-5592-8758-6E2CECC855D9}"/>
                </a:ext>
              </a:extLst>
            </p:cNvPr>
            <p:cNvGrpSpPr/>
            <p:nvPr/>
          </p:nvGrpSpPr>
          <p:grpSpPr>
            <a:xfrm>
              <a:off x="493964" y="807435"/>
              <a:ext cx="5426988" cy="5157352"/>
              <a:chOff x="493964" y="807435"/>
              <a:chExt cx="5426988" cy="5157352"/>
            </a:xfrm>
          </p:grpSpPr>
          <p:sp>
            <p:nvSpPr>
              <p:cNvPr id="7" name="Diamond 6">
                <a:extLst>
                  <a:ext uri="{FF2B5EF4-FFF2-40B4-BE49-F238E27FC236}">
                    <a16:creationId xmlns:a16="http://schemas.microsoft.com/office/drawing/2014/main" id="{BF637F33-D6B4-A777-5C37-450724E8018D}"/>
                  </a:ext>
                </a:extLst>
              </p:cNvPr>
              <p:cNvSpPr/>
              <p:nvPr/>
            </p:nvSpPr>
            <p:spPr>
              <a:xfrm>
                <a:off x="493964" y="807435"/>
                <a:ext cx="2378421" cy="2079620"/>
              </a:xfrm>
              <a:prstGeom prst="diamond">
                <a:avLst/>
              </a:prstGeom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/>
                  <a:t>Are there ≥15 eosinophils per high-power field (</a:t>
                </a:r>
                <a:r>
                  <a:rPr lang="en-US" sz="1200" dirty="0" err="1"/>
                  <a:t>eos</a:t>
                </a:r>
                <a:r>
                  <a:rPr lang="en-US" sz="1200" dirty="0"/>
                  <a:t>/</a:t>
                </a:r>
                <a:r>
                  <a:rPr lang="en-US" sz="1200" dirty="0" err="1"/>
                  <a:t>hpf</a:t>
                </a:r>
                <a:r>
                  <a:rPr lang="en-US" sz="1200" dirty="0"/>
                  <a:t>)?</a:t>
                </a:r>
              </a:p>
            </p:txBody>
          </p:sp>
          <p:cxnSp>
            <p:nvCxnSpPr>
              <p:cNvPr id="9" name="Straight Arrow Connector 8">
                <a:extLst>
                  <a:ext uri="{FF2B5EF4-FFF2-40B4-BE49-F238E27FC236}">
                    <a16:creationId xmlns:a16="http://schemas.microsoft.com/office/drawing/2014/main" id="{2927CEA8-EFB4-EE13-F191-599D16A538A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67860" y="2721685"/>
                <a:ext cx="2988" cy="926352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accent6"/>
              </a:lnRef>
              <a:fillRef idx="0">
                <a:schemeClr val="accent6"/>
              </a:fillRef>
              <a:effectRef idx="2">
                <a:schemeClr val="accent6"/>
              </a:effectRef>
              <a:fontRef idx="minor">
                <a:schemeClr val="tx1"/>
              </a:fontRef>
            </p:style>
          </p:cxnSp>
          <p:cxnSp>
            <p:nvCxnSpPr>
              <p:cNvPr id="11" name="Straight Arrow Connector 10">
                <a:extLst>
                  <a:ext uri="{FF2B5EF4-FFF2-40B4-BE49-F238E27FC236}">
                    <a16:creationId xmlns:a16="http://schemas.microsoft.com/office/drawing/2014/main" id="{0C337E24-B597-E8CE-01E1-15A59C6A2DD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695388" y="1833346"/>
                <a:ext cx="857621" cy="16568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accent6"/>
              </a:lnRef>
              <a:fillRef idx="0">
                <a:schemeClr val="accent6"/>
              </a:fillRef>
              <a:effectRef idx="2">
                <a:schemeClr val="accent6"/>
              </a:effectRef>
              <a:fontRef idx="minor">
                <a:schemeClr val="tx1"/>
              </a:fontRef>
            </p:style>
          </p:cxnSp>
          <p:sp>
            <p:nvSpPr>
              <p:cNvPr id="16" name="Diamond 15">
                <a:extLst>
                  <a:ext uri="{FF2B5EF4-FFF2-40B4-BE49-F238E27FC236}">
                    <a16:creationId xmlns:a16="http://schemas.microsoft.com/office/drawing/2014/main" id="{95D22F5B-2BF8-DB33-F7A1-ED1B0624E39B}"/>
                  </a:ext>
                </a:extLst>
              </p:cNvPr>
              <p:cNvSpPr/>
              <p:nvPr/>
            </p:nvSpPr>
            <p:spPr>
              <a:xfrm>
                <a:off x="3474363" y="833690"/>
                <a:ext cx="2371304" cy="1973634"/>
              </a:xfrm>
              <a:prstGeom prst="diamond">
                <a:avLst/>
              </a:prstGeom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/>
                  <a:t>Is the immune profile Th2-dominant?</a:t>
                </a:r>
              </a:p>
              <a:p>
                <a:pPr algn="ctr"/>
                <a:r>
                  <a:rPr lang="en-US" sz="800" dirty="0"/>
                  <a:t>↑ </a:t>
                </a:r>
                <a:r>
                  <a:rPr lang="en-US" sz="800" b="1" dirty="0"/>
                  <a:t>IL4, IL5, IL13; </a:t>
                </a:r>
                <a:r>
                  <a:rPr lang="en-US" sz="800" dirty="0"/>
                  <a:t>↓ zinc-responsive genes like </a:t>
                </a:r>
                <a:r>
                  <a:rPr lang="en-US" sz="800" b="1" dirty="0"/>
                  <a:t>MT1X, MT2A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B37F4CB2-3543-0820-3D55-E9F225E07FB7}"/>
                  </a:ext>
                </a:extLst>
              </p:cNvPr>
              <p:cNvSpPr txBox="1"/>
              <p:nvPr/>
            </p:nvSpPr>
            <p:spPr>
              <a:xfrm>
                <a:off x="1748115" y="3049352"/>
                <a:ext cx="729130" cy="3395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Yes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5F3B4BB3-023A-2C8C-4F18-25810E5E0191}"/>
                  </a:ext>
                </a:extLst>
              </p:cNvPr>
              <p:cNvSpPr txBox="1"/>
              <p:nvPr/>
            </p:nvSpPr>
            <p:spPr>
              <a:xfrm>
                <a:off x="2880658" y="1519129"/>
                <a:ext cx="522943" cy="3395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No</a:t>
                </a:r>
              </a:p>
            </p:txBody>
          </p:sp>
          <p:cxnSp>
            <p:nvCxnSpPr>
              <p:cNvPr id="22" name="Straight Arrow Connector 21">
                <a:extLst>
                  <a:ext uri="{FF2B5EF4-FFF2-40B4-BE49-F238E27FC236}">
                    <a16:creationId xmlns:a16="http://schemas.microsoft.com/office/drawing/2014/main" id="{35C87836-EE8F-3C97-6C58-E7614BE941E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57373" y="2715576"/>
                <a:ext cx="0" cy="917387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3">
                <a:schemeClr val="accent6"/>
              </a:lnRef>
              <a:fillRef idx="0">
                <a:schemeClr val="accent6"/>
              </a:fillRef>
              <a:effectRef idx="2">
                <a:schemeClr val="accent6"/>
              </a:effectRef>
              <a:fontRef idx="minor">
                <a:schemeClr val="tx1"/>
              </a:fontRef>
            </p:style>
          </p:cxn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03A50A9D-07B5-A838-1F04-D89CB697C541}"/>
                  </a:ext>
                </a:extLst>
              </p:cNvPr>
              <p:cNvSpPr txBox="1"/>
              <p:nvPr/>
            </p:nvSpPr>
            <p:spPr>
              <a:xfrm>
                <a:off x="4688537" y="3066410"/>
                <a:ext cx="534662" cy="3395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Yes</a:t>
                </a:r>
              </a:p>
            </p:txBody>
          </p:sp>
          <p:sp>
            <p:nvSpPr>
              <p:cNvPr id="54" name="Rectangle: Single Corner Snipped 53">
                <a:extLst>
                  <a:ext uri="{FF2B5EF4-FFF2-40B4-BE49-F238E27FC236}">
                    <a16:creationId xmlns:a16="http://schemas.microsoft.com/office/drawing/2014/main" id="{1D76B053-E70D-A258-FB8D-58559A054719}"/>
                  </a:ext>
                </a:extLst>
              </p:cNvPr>
              <p:cNvSpPr/>
              <p:nvPr/>
            </p:nvSpPr>
            <p:spPr>
              <a:xfrm>
                <a:off x="702978" y="4663968"/>
                <a:ext cx="2177681" cy="1300819"/>
              </a:xfrm>
              <a:prstGeom prst="snip1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sz="1200" dirty="0"/>
                  <a:t>Plus: Check for supportive molecular markers:</a:t>
                </a:r>
              </a:p>
              <a:p>
                <a:r>
                  <a:rPr lang="en-US" sz="1200" dirty="0"/>
                  <a:t>↑ </a:t>
                </a:r>
                <a:r>
                  <a:rPr lang="en-US" sz="1200" b="1" dirty="0"/>
                  <a:t>POSTN</a:t>
                </a:r>
              </a:p>
              <a:p>
                <a:r>
                  <a:rPr lang="en-US" sz="1200" dirty="0"/>
                  <a:t>↑ </a:t>
                </a:r>
                <a:r>
                  <a:rPr lang="en-US" sz="1200" b="1" dirty="0"/>
                  <a:t>DNAH11</a:t>
                </a:r>
                <a:endParaRPr lang="en-US" sz="1200" dirty="0"/>
              </a:p>
              <a:p>
                <a:endParaRPr lang="en-US" sz="1000" dirty="0"/>
              </a:p>
            </p:txBody>
          </p:sp>
          <p:sp>
            <p:nvSpPr>
              <p:cNvPr id="55" name="Plus Sign 54">
                <a:extLst>
                  <a:ext uri="{FF2B5EF4-FFF2-40B4-BE49-F238E27FC236}">
                    <a16:creationId xmlns:a16="http://schemas.microsoft.com/office/drawing/2014/main" id="{ED6FA5D4-59B5-EE91-607F-CA705F78DE2A}"/>
                  </a:ext>
                </a:extLst>
              </p:cNvPr>
              <p:cNvSpPr/>
              <p:nvPr/>
            </p:nvSpPr>
            <p:spPr>
              <a:xfrm>
                <a:off x="1540061" y="4413028"/>
                <a:ext cx="152393" cy="143436"/>
              </a:xfrm>
              <a:prstGeom prst="mathPlus">
                <a:avLst/>
              </a:prstGeom>
            </p:spPr>
            <p:style>
              <a:lnRef idx="1">
                <a:schemeClr val="dk1"/>
              </a:lnRef>
              <a:fillRef idx="3">
                <a:schemeClr val="dk1"/>
              </a:fillRef>
              <a:effectRef idx="2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3" name="Rectangle: Diagonal Corners Rounded 62">
                <a:extLst>
                  <a:ext uri="{FF2B5EF4-FFF2-40B4-BE49-F238E27FC236}">
                    <a16:creationId xmlns:a16="http://schemas.microsoft.com/office/drawing/2014/main" id="{64C219FD-15FE-F8FC-2D26-ADD3F75B5D10}"/>
                  </a:ext>
                </a:extLst>
              </p:cNvPr>
              <p:cNvSpPr/>
              <p:nvPr/>
            </p:nvSpPr>
            <p:spPr>
              <a:xfrm>
                <a:off x="687610" y="3627613"/>
                <a:ext cx="2135018" cy="631501"/>
              </a:xfrm>
              <a:prstGeom prst="round2DiagRect">
                <a:avLst>
                  <a:gd name="adj1" fmla="val 16667"/>
                  <a:gd name="adj2" fmla="val 0"/>
                </a:avLst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/>
                  <a:t>Proceed to confirm Conventional </a:t>
                </a:r>
                <a:r>
                  <a:rPr lang="en-US" sz="1200" dirty="0" err="1"/>
                  <a:t>EoE</a:t>
                </a:r>
                <a:endParaRPr lang="en-US" sz="1200" dirty="0"/>
              </a:p>
            </p:txBody>
          </p:sp>
          <p:sp>
            <p:nvSpPr>
              <p:cNvPr id="64" name="Rectangle: Diagonal Corners Rounded 63">
                <a:extLst>
                  <a:ext uri="{FF2B5EF4-FFF2-40B4-BE49-F238E27FC236}">
                    <a16:creationId xmlns:a16="http://schemas.microsoft.com/office/drawing/2014/main" id="{1DAACE04-537A-4A2E-3F16-9FEDB947FCB3}"/>
                  </a:ext>
                </a:extLst>
              </p:cNvPr>
              <p:cNvSpPr/>
              <p:nvPr/>
            </p:nvSpPr>
            <p:spPr>
              <a:xfrm>
                <a:off x="3555625" y="3632963"/>
                <a:ext cx="2365327" cy="780056"/>
              </a:xfrm>
              <a:prstGeom prst="round2Diag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6"/>
              </a:lnRef>
              <a:fillRef idx="3">
                <a:schemeClr val="accent6"/>
              </a:fillRef>
              <a:effectRef idx="2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/>
                  <a:t>Confirm Conventional EoE, even with borderline </a:t>
                </a:r>
                <a:r>
                  <a:rPr lang="en-US" sz="1200" dirty="0" err="1"/>
                  <a:t>eos</a:t>
                </a:r>
                <a:r>
                  <a:rPr lang="en-US" sz="1200" dirty="0"/>
                  <a:t>/</a:t>
                </a:r>
                <a:r>
                  <a:rPr lang="en-US" sz="1200" dirty="0" err="1"/>
                  <a:t>hpf</a:t>
                </a:r>
                <a:endParaRPr lang="en-US" sz="1200" dirty="0"/>
              </a:p>
            </p:txBody>
          </p:sp>
        </p:grp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1943AA3B-F950-856C-B5A7-5C8EDB170BFD}"/>
              </a:ext>
            </a:extLst>
          </p:cNvPr>
          <p:cNvSpPr txBox="1"/>
          <p:nvPr/>
        </p:nvSpPr>
        <p:spPr>
          <a:xfrm>
            <a:off x="221254" y="6434035"/>
            <a:ext cx="609721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/>
              <a:t>Supplementary Material 2 – S1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503370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77</TotalTime>
  <Words>143</Words>
  <Application>Microsoft Macintosh PowerPoint</Application>
  <PresentationFormat>Widescreen</PresentationFormat>
  <Paragraphs>3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TOWARDS AN IMMUNOLOGICAL DIAGNOSTIC FRAMEWORK EOE AND ITS SUBTYP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ric Agyei Twum</dc:creator>
  <cp:lastModifiedBy>Aman Ullah</cp:lastModifiedBy>
  <cp:revision>11</cp:revision>
  <dcterms:created xsi:type="dcterms:W3CDTF">2025-08-15T01:48:10Z</dcterms:created>
  <dcterms:modified xsi:type="dcterms:W3CDTF">2026-02-11T14:15:21Z</dcterms:modified>
</cp:coreProperties>
</file>